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6" r:id="rId2"/>
    <p:sldId id="344" r:id="rId3"/>
    <p:sldId id="346" r:id="rId4"/>
    <p:sldId id="348" r:id="rId5"/>
    <p:sldId id="350" r:id="rId6"/>
    <p:sldId id="261" r:id="rId7"/>
    <p:sldId id="355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F1D7F64-390B-4EB1-B872-9AA3015D0871}" v="17" dt="2022-01-20T09:36:57.271"/>
    <p1510:client id="{C386C4C6-8CB2-480F-80AF-D06489A7D740}" v="2" dt="2021-06-18T12:50:56.51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60"/>
    <p:restoredTop sz="94694"/>
  </p:normalViewPr>
  <p:slideViewPr>
    <p:cSldViewPr>
      <p:cViewPr varScale="1">
        <p:scale>
          <a:sx n="105" d="100"/>
          <a:sy n="105" d="100"/>
        </p:scale>
        <p:origin x="192" y="5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387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503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165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6111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405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0821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9655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5061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7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545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7340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306F0-A08F-4E87-AEEB-99AF4AE78060}" type="datetimeFigureOut">
              <a:rPr lang="en-GB" smtClean="0"/>
              <a:t>30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0E720-917B-4C52-AF59-BBE3F49B92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7851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flowchart of a flowchart&#10;&#10;Description automatically generated">
            <a:extLst>
              <a:ext uri="{FF2B5EF4-FFF2-40B4-BE49-F238E27FC236}">
                <a16:creationId xmlns:a16="http://schemas.microsoft.com/office/drawing/2014/main" id="{A69EE055-60FE-ACF5-8CE9-F654D3FA26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9211" y="643466"/>
            <a:ext cx="5833578" cy="55710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E6FA660-5191-49D7-7CD6-02CC662DA554}"/>
              </a:ext>
            </a:extLst>
          </p:cNvPr>
          <p:cNvSpPr txBox="1"/>
          <p:nvPr/>
        </p:nvSpPr>
        <p:spPr>
          <a:xfrm>
            <a:off x="1343472" y="209787"/>
            <a:ext cx="103275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1 –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SMA flow diagram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413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879976" y="1484785"/>
            <a:ext cx="3240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Range: 4 weeks to 26 weeks</a:t>
            </a:r>
          </a:p>
          <a:p>
            <a:endParaRPr lang="en-GB" sz="1800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0432452"/>
              </p:ext>
            </p:extLst>
          </p:nvPr>
        </p:nvGraphicFramePr>
        <p:xfrm>
          <a:off x="1991544" y="1124745"/>
          <a:ext cx="3456384" cy="5042897"/>
        </p:xfrm>
        <a:graphic>
          <a:graphicData uri="http://schemas.openxmlformats.org/drawingml/2006/table">
            <a:tbl>
              <a:tblPr/>
              <a:tblGrid>
                <a:gridCol w="17281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31976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udy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ing of assessment 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816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after completion of treatment)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426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thews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-6 month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426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on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month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7363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-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adaad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426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zinge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426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erbe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-6 month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426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James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5872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iffert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 month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rehange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ulendijk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 </a:t>
                      </a:r>
                      <a:r>
                        <a:rPr lang="en-GB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-6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aretelink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816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nne-Jones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507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uloulias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816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delman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rrigno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507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resoli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507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abenbauer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am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-6 weeks 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31976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lama et al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147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e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5629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rtenson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 week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347447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agner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 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61258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ndhu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7507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wang et al. </a:t>
                      </a:r>
                      <a:r>
                        <a:rPr lang="en-GB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days</a:t>
                      </a:r>
                    </a:p>
                  </a:txBody>
                  <a:tcPr marL="2693" marR="2693" marT="269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866203"/>
              </p:ext>
            </p:extLst>
          </p:nvPr>
        </p:nvGraphicFramePr>
        <p:xfrm>
          <a:off x="5998049" y="1807949"/>
          <a:ext cx="4267200" cy="97917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6672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Week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2 to 2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Number of studies</a:t>
                      </a:r>
                    </a:p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C95C1E1-4B27-E9BD-F490-094576C4548D}"/>
              </a:ext>
            </a:extLst>
          </p:cNvPr>
          <p:cNvSpPr txBox="1"/>
          <p:nvPr/>
        </p:nvSpPr>
        <p:spPr>
          <a:xfrm>
            <a:off x="932233" y="6282574"/>
            <a:ext cx="103275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– Timepoints used for assessment of treatment response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3590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6728111"/>
              </p:ext>
            </p:extLst>
          </p:nvPr>
        </p:nvGraphicFramePr>
        <p:xfrm>
          <a:off x="4151783" y="732040"/>
          <a:ext cx="3888432" cy="5393920"/>
        </p:xfrm>
        <a:graphic>
          <a:graphicData uri="http://schemas.openxmlformats.org/drawingml/2006/table">
            <a:tbl>
              <a:tblPr/>
              <a:tblGrid>
                <a:gridCol w="11521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363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ud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dalit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thew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inically or radiologicall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on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-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adaad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zinger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erber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Jame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iffert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inically, radiologically, biochemically or pathologicall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59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rehange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ulendijks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ysical examinatio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aretelink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ysical examinatio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nne-Jone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ysical examination and/or CT/MRI sca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uloulias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ysical examination and CT sca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delman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hysical examination and endoscop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rrigno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ndoscopy and histolog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resoli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olog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abenbauer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olog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am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olog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lama et al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inically NO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e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inically NO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5205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rtenson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inically NO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19900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agner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2574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ndhu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178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wang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specifi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F01CB31-FECA-EF90-386D-DDC609560A6B}"/>
              </a:ext>
            </a:extLst>
          </p:cNvPr>
          <p:cNvSpPr txBox="1"/>
          <p:nvPr/>
        </p:nvSpPr>
        <p:spPr>
          <a:xfrm>
            <a:off x="1639973" y="6237312"/>
            <a:ext cx="89120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B – Timepoints used for assessment of treatment response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28344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3809021"/>
              </p:ext>
            </p:extLst>
          </p:nvPr>
        </p:nvGraphicFramePr>
        <p:xfrm>
          <a:off x="1487488" y="116632"/>
          <a:ext cx="9217024" cy="6173926"/>
        </p:xfrm>
        <a:graphic>
          <a:graphicData uri="http://schemas.openxmlformats.org/drawingml/2006/table">
            <a:tbl>
              <a:tblPr/>
              <a:tblGrid>
                <a:gridCol w="12903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434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729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9355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747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ud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let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rtial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bl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gressiv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3617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GB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CIST  criteria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thew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sappearance of target lesion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 least 40% reduction in sum of diameters of target lesion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sufficient shrinkage/growth to qualify for partial response or progressive disea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6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 least 20% increase in sum of diameters of target lesion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on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-</a:t>
                      </a:r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adaad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tzinger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erber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Jame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3617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GB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HO criteria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iffert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sappearance of all known disease on 2 observations 4 weeks apart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% or more decrease in tumour load/estimated siz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sufficient shrinkage/growth to qualify for partial response or progressive disea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% or more increase in size of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05736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rehange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3617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GB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ther criteria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2522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ulendijks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et al. 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lete resolution of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aretelink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t defin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66485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nne-Jones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bsence of clinically detectable disea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66485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uloulias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% tumour regressio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% decrease in tumour volum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% decrease in tumour volum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crease in tumour volume of &gt;25%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delman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 tumour detectabl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errigno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 tumour detectabl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62522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resoli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sappearance of neoplastic cell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62522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abenbauer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lete tumour regressio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am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gative biops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lama et al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 residual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y residual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ss than 30% respon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62522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e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sappearance of the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&gt;50% reduction in the largest tumour diamete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36935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rtenson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lete disappearance of detectable disea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crease of 50% or more in the product of the longest diameter and the greatest perpendicular diamete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66485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agner et al.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regression of the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gression of more than 50% of the initial volume of the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66485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ndhu </a:t>
                      </a:r>
                      <a:r>
                        <a:rPr lang="en-GB" sz="8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cording to standard practic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nimal induration with no evidence of frank tumou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361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wang et al. </a:t>
                      </a:r>
                      <a:r>
                        <a:rPr lang="en-GB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o evidence of disease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D015DB43-A7B8-D53D-EEA4-DD53CAC6F4E1}"/>
              </a:ext>
            </a:extLst>
          </p:cNvPr>
          <p:cNvSpPr txBox="1"/>
          <p:nvPr/>
        </p:nvSpPr>
        <p:spPr>
          <a:xfrm>
            <a:off x="1639973" y="6325789"/>
            <a:ext cx="89120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C – Modalities used for assessment of treatment response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18235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78469081"/>
              </p:ext>
            </p:extLst>
          </p:nvPr>
        </p:nvGraphicFramePr>
        <p:xfrm>
          <a:off x="3930586" y="1415440"/>
          <a:ext cx="4330824" cy="4027119"/>
        </p:xfrm>
        <a:graphic>
          <a:graphicData uri="http://schemas.openxmlformats.org/drawingml/2006/table">
            <a:tbl>
              <a:tblPr bandRow="1">
                <a:tableStyleId>{9D7B26C5-4107-4FEC-AEDC-1716B250A1EF}</a:tableStyleId>
              </a:tblPr>
              <a:tblGrid>
                <a:gridCol w="38987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20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Local failur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9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</a:rPr>
                        <a:t>8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 definition give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Evidence of persistent local disease or local recurrenc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Tumour recurrence at the primary site after complete initial regress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 err="1">
                          <a:effectLst/>
                        </a:rPr>
                        <a:t>Locoregional</a:t>
                      </a:r>
                      <a:r>
                        <a:rPr lang="en-GB" sz="1000" b="1" u="none" strike="noStrike" dirty="0">
                          <a:effectLst/>
                        </a:rPr>
                        <a:t> failur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9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</a:rPr>
                        <a:t>6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 definition give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Both local and pelvic recurrenc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469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Disease recurrence within the anal canal and/or anal margin and/or </a:t>
                      </a:r>
                      <a:r>
                        <a:rPr lang="en-GB" sz="1000" u="none" strike="noStrike" dirty="0" err="1">
                          <a:effectLst/>
                        </a:rPr>
                        <a:t>mesorectum</a:t>
                      </a:r>
                      <a:r>
                        <a:rPr lang="en-GB" sz="1000" u="none" strike="noStrike" dirty="0">
                          <a:effectLst/>
                        </a:rPr>
                        <a:t> and/or draining lymph nodes (inguinal, external iliac, internal iliac, obturator, perirectal or </a:t>
                      </a:r>
                      <a:r>
                        <a:rPr lang="en-GB" sz="1000" u="none" strike="noStrike" dirty="0" err="1">
                          <a:effectLst/>
                        </a:rPr>
                        <a:t>presacral</a:t>
                      </a:r>
                      <a:r>
                        <a:rPr lang="en-GB" sz="1000" u="none" strike="noStrike" dirty="0">
                          <a:effectLst/>
                        </a:rPr>
                        <a:t> nodes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469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Local disease persistence/ recurrence/ progression, positive </a:t>
                      </a:r>
                      <a:r>
                        <a:rPr lang="en-GB" sz="1000" u="none" strike="noStrike" dirty="0" err="1">
                          <a:effectLst/>
                        </a:rPr>
                        <a:t>biospy</a:t>
                      </a:r>
                      <a:r>
                        <a:rPr lang="en-GB" sz="1000" u="none" strike="noStrike" dirty="0">
                          <a:effectLst/>
                        </a:rPr>
                        <a:t>, surgery for primary or disease presence/ recurrence/ progression in lymph node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Local or regional recurrence or progressio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Regional failur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9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</a:rPr>
                        <a:t>4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 definition give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Evidence of persistence, appearance or recurrence of regional nodal disea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Pelvic or inguinal relap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Metastatic failur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9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</a:rPr>
                        <a:t>3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No definition give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 err="1">
                          <a:effectLst/>
                        </a:rPr>
                        <a:t>Extrapelvic</a:t>
                      </a:r>
                      <a:r>
                        <a:rPr lang="en-GB" sz="1000" u="none" strike="noStrike" dirty="0">
                          <a:effectLst/>
                        </a:rPr>
                        <a:t> relaps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u="none" strike="noStrike" dirty="0">
                          <a:effectLst/>
                        </a:rPr>
                        <a:t>Systemic failur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9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</a:rPr>
                        <a:t>1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3865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 dirty="0">
                          <a:effectLst/>
                        </a:rPr>
                        <a:t>Disease recurrence outside area defined for </a:t>
                      </a:r>
                      <a:r>
                        <a:rPr lang="en-GB" sz="1000" u="none" strike="noStrike" dirty="0" err="1">
                          <a:effectLst/>
                        </a:rPr>
                        <a:t>locoregional</a:t>
                      </a:r>
                      <a:r>
                        <a:rPr lang="en-GB" sz="1000" u="none" strike="noStrike" dirty="0">
                          <a:effectLst/>
                        </a:rPr>
                        <a:t> failure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56478" marR="8693" marT="86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693" marR="8693" marT="8693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DC700AA-B1C6-1A2B-C194-AD923597D19E}"/>
              </a:ext>
            </a:extLst>
          </p:cNvPr>
          <p:cNvSpPr txBox="1"/>
          <p:nvPr/>
        </p:nvSpPr>
        <p:spPr>
          <a:xfrm>
            <a:off x="2499833" y="5877272"/>
            <a:ext cx="71923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D – Definitions of treatment failure used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56538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9529860"/>
              </p:ext>
            </p:extLst>
          </p:nvPr>
        </p:nvGraphicFramePr>
        <p:xfrm>
          <a:off x="2423593" y="2253584"/>
          <a:ext cx="5770983" cy="1494941"/>
        </p:xfrm>
        <a:graphic>
          <a:graphicData uri="http://schemas.openxmlformats.org/drawingml/2006/table">
            <a:tbl>
              <a:tblPr/>
              <a:tblGrid>
                <a:gridCol w="139797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63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639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157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9360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5086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1291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ference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ogressive disease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apse/ recurrence  NOS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rsistent disease/ local recurrence/ failure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astases/ distant failure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ath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863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e et al.145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8633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ordermark et al.146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2806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lano et al.147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6456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Koerber et al.121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6456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ames et al.5 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6456">
                <a:tc>
                  <a:txBody>
                    <a:bodyPr/>
                    <a:lstStyle/>
                    <a:p>
                      <a:pPr algn="l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tzinger et al.120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</a:p>
                  </a:txBody>
                  <a:tcPr marL="7823" marR="7823" marT="782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3950524"/>
              </p:ext>
            </p:extLst>
          </p:nvPr>
        </p:nvGraphicFramePr>
        <p:xfrm>
          <a:off x="2423592" y="4557840"/>
          <a:ext cx="4608512" cy="912495"/>
        </p:xfrm>
        <a:graphic>
          <a:graphicData uri="http://schemas.openxmlformats.org/drawingml/2006/table">
            <a:tbl>
              <a:tblPr/>
              <a:tblGrid>
                <a:gridCol w="12961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123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0416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CIS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 least 20% increase in sum of diameters of target lesion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416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HO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% or more increase in size of tumou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4165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thers from literatur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ncrease in tumour volume of &gt;2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4683651"/>
              </p:ext>
            </p:extLst>
          </p:nvPr>
        </p:nvGraphicFramePr>
        <p:xfrm>
          <a:off x="2423592" y="813423"/>
          <a:ext cx="6912768" cy="1143000"/>
        </p:xfrm>
        <a:graphic>
          <a:graphicData uri="http://schemas.openxmlformats.org/drawingml/2006/table">
            <a:tbl>
              <a:tblPr bandRow="1">
                <a:tableStyleId>{9D7B26C5-4107-4FEC-AEDC-1716B250A1EF}</a:tableStyleId>
              </a:tblPr>
              <a:tblGrid>
                <a:gridCol w="15121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400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Lee et al.14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First documented relapse in patients who attained complete respon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Vordermark et al.14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Histological evidence of tumour recurrence or death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Milano et al.1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Persistent disease after treatment, local failure or distant failur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Koerber et al.12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Progressive disease or death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James et al.5 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Progressive disease, local recurrence, metastases or death from any cau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Matzinger et al.1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Relapse or death of any cau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423592" y="381375"/>
            <a:ext cx="70567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Definitions of PFS: Progression as event but progression not define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23592" y="4129092"/>
            <a:ext cx="6408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/>
              <a:t>Definitions of progression from treatment response criteria: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42FD82-C3E9-1AA1-2096-B93C18EEB212}"/>
              </a:ext>
            </a:extLst>
          </p:cNvPr>
          <p:cNvSpPr txBox="1"/>
          <p:nvPr/>
        </p:nvSpPr>
        <p:spPr>
          <a:xfrm>
            <a:off x="2166392" y="5736528"/>
            <a:ext cx="74271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E – Definitions of disease progression used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23780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755391565"/>
              </p:ext>
            </p:extLst>
          </p:nvPr>
        </p:nvGraphicFramePr>
        <p:xfrm>
          <a:off x="2548722" y="980728"/>
          <a:ext cx="7109146" cy="4525958"/>
        </p:xfrm>
        <a:graphic>
          <a:graphicData uri="http://schemas.openxmlformats.org/drawingml/2006/table">
            <a:tbl>
              <a:tblPr/>
              <a:tblGrid>
                <a:gridCol w="149114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833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0196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756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2033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5917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5917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5917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5917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470253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lapse/ recurrence NOS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gressive disease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cal relapse/ failure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gional relapse/ failure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stant relapse/ failure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cond primary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ncer related death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ath from any cause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resoli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-Hadaad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97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vencher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ranco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97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iffert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ndenhall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u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97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mpson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4741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ndrely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4741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ng et al. 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ates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1037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schy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9778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ureau-Zabotto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4741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ichenadasse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4741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uong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60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underson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l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Wingdings"/>
                        </a:rPr>
                        <a:t>ü</a:t>
                      </a:r>
                      <a:r>
                        <a:rPr lang="en-GB" sz="1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  <a:endParaRPr lang="en-GB" sz="1500" b="0" i="0" u="none" strike="noStrike">
                        <a:solidFill>
                          <a:srgbClr val="000000"/>
                        </a:solidFill>
                        <a:effectLst/>
                        <a:latin typeface="Wingdings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BFBF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60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ung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60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jani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60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nski et al.</a:t>
                      </a:r>
                      <a:r>
                        <a:rPr lang="en-GB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60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am et al.</a:t>
                      </a:r>
                      <a:r>
                        <a:rPr lang="en-GB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8741" marR="8741" marT="874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131C638-5E98-2A10-3B3F-16CF8EAEB879}"/>
              </a:ext>
            </a:extLst>
          </p:cNvPr>
          <p:cNvSpPr txBox="1"/>
          <p:nvPr/>
        </p:nvSpPr>
        <p:spPr>
          <a:xfrm>
            <a:off x="2252983" y="5877272"/>
            <a:ext cx="77006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2F – Definitions of disease-free survival used </a:t>
            </a:r>
            <a:r>
              <a:rPr lang="en-AU" altLang="en-US" i="1" dirty="0">
                <a:solidFill>
                  <a:srgbClr val="44546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RT studies for ASCC</a:t>
            </a:r>
            <a:r>
              <a:rPr kumimoji="0" lang="en-AU" altLang="en-US" sz="18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kumimoji="0" lang="en-GB" altLang="en-US" sz="1800" b="0" i="1" u="none" strike="noStrike" cap="none" normalizeH="0" baseline="0" dirty="0">
              <a:ln>
                <a:noFill/>
              </a:ln>
              <a:solidFill>
                <a:srgbClr val="44546A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3327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olstice">
      <a:majorFont>
        <a:latin typeface="Gill Sans MT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/>
        <a:ea typeface=""/>
        <a:cs typeface=""/>
        <a:font script="Grek" typeface="Corbel"/>
        <a:font script="Cyrl" typeface="Corbel"/>
        <a:font script="Jpan" typeface="HGｺﾞｼｯｸE"/>
        <a:font script="Hang" typeface="HY엽서L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Waveform</Template>
  <TotalTime>1542</TotalTime>
  <Words>1342</Words>
  <Application>Microsoft Macintosh PowerPoint</Application>
  <PresentationFormat>Widescreen</PresentationFormat>
  <Paragraphs>38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Gill Sans MT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Christie NHS Foundation Tru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sh Rebecca (RBV) NHS Christie Tr</dc:creator>
  <cp:lastModifiedBy>Robert Samuel</cp:lastModifiedBy>
  <cp:revision>38</cp:revision>
  <dcterms:created xsi:type="dcterms:W3CDTF">2021-06-18T11:21:50Z</dcterms:created>
  <dcterms:modified xsi:type="dcterms:W3CDTF">2024-09-30T09:04:58Z</dcterms:modified>
</cp:coreProperties>
</file>